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8"/>
    <p:restoredTop sz="94646"/>
  </p:normalViewPr>
  <p:slideViewPr>
    <p:cSldViewPr snapToGrid="0" snapToObjects="1" showGuides="1">
      <p:cViewPr varScale="1">
        <p:scale>
          <a:sx n="93" d="100"/>
          <a:sy n="93" d="100"/>
        </p:scale>
        <p:origin x="-120" y="-55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B7297D-32A6-4540-BA0D-2AB4E33BD1D2}" type="datetimeFigureOut">
              <a:rPr lang="en-US" smtClean="0"/>
              <a:t>5/1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3DE8D8-C96E-EF4D-A53E-271F8C86FB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80878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B7297D-32A6-4540-BA0D-2AB4E33BD1D2}" type="datetimeFigureOut">
              <a:rPr lang="en-US" smtClean="0"/>
              <a:t>5/1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3DE8D8-C96E-EF4D-A53E-271F8C86FB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37217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B7297D-32A6-4540-BA0D-2AB4E33BD1D2}" type="datetimeFigureOut">
              <a:rPr lang="en-US" smtClean="0"/>
              <a:t>5/1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3DE8D8-C96E-EF4D-A53E-271F8C86FB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08002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B7297D-32A6-4540-BA0D-2AB4E33BD1D2}" type="datetimeFigureOut">
              <a:rPr lang="en-US" smtClean="0"/>
              <a:t>5/1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3DE8D8-C96E-EF4D-A53E-271F8C86FB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45843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B7297D-32A6-4540-BA0D-2AB4E33BD1D2}" type="datetimeFigureOut">
              <a:rPr lang="en-US" smtClean="0"/>
              <a:t>5/1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3DE8D8-C96E-EF4D-A53E-271F8C86FB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5365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B7297D-32A6-4540-BA0D-2AB4E33BD1D2}" type="datetimeFigureOut">
              <a:rPr lang="en-US" smtClean="0"/>
              <a:t>5/1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3DE8D8-C96E-EF4D-A53E-271F8C86FB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83000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B7297D-32A6-4540-BA0D-2AB4E33BD1D2}" type="datetimeFigureOut">
              <a:rPr lang="en-US" smtClean="0"/>
              <a:t>5/13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3DE8D8-C96E-EF4D-A53E-271F8C86FB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27831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B7297D-32A6-4540-BA0D-2AB4E33BD1D2}" type="datetimeFigureOut">
              <a:rPr lang="en-US" smtClean="0"/>
              <a:t>5/13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3DE8D8-C96E-EF4D-A53E-271F8C86FB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75367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B7297D-32A6-4540-BA0D-2AB4E33BD1D2}" type="datetimeFigureOut">
              <a:rPr lang="en-US" smtClean="0"/>
              <a:t>5/13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3DE8D8-C96E-EF4D-A53E-271F8C86FB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59200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B7297D-32A6-4540-BA0D-2AB4E33BD1D2}" type="datetimeFigureOut">
              <a:rPr lang="en-US" smtClean="0"/>
              <a:t>5/1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3DE8D8-C96E-EF4D-A53E-271F8C86FB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2635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B7297D-32A6-4540-BA0D-2AB4E33BD1D2}" type="datetimeFigureOut">
              <a:rPr lang="en-US" smtClean="0"/>
              <a:t>5/1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3DE8D8-C96E-EF4D-A53E-271F8C86FB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10859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B7297D-32A6-4540-BA0D-2AB4E33BD1D2}" type="datetimeFigureOut">
              <a:rPr lang="en-US" smtClean="0"/>
              <a:t>5/1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3DE8D8-C96E-EF4D-A53E-271F8C86FB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69052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36017755"/>
              </p:ext>
            </p:extLst>
          </p:nvPr>
        </p:nvGraphicFramePr>
        <p:xfrm>
          <a:off x="397042" y="532648"/>
          <a:ext cx="8980727" cy="1991429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460534"/>
                <a:gridCol w="571534"/>
                <a:gridCol w="1765334"/>
                <a:gridCol w="741397"/>
                <a:gridCol w="1874872"/>
                <a:gridCol w="1984409"/>
                <a:gridCol w="582647"/>
              </a:tblGrid>
              <a:tr h="114507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1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Target</a:t>
                      </a:r>
                      <a:endParaRPr lang="en-US" sz="700" b="1" i="1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1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rimer</a:t>
                      </a:r>
                      <a:endParaRPr lang="en-US" sz="700" b="1" i="1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700" b="1" i="1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Sequence (5'-3')</a:t>
                      </a:r>
                      <a:endParaRPr lang="mr-IN" sz="700" b="1" i="1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1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mplicon length</a:t>
                      </a:r>
                      <a:endParaRPr lang="en-US" sz="700" b="1" i="1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1" u="none" strike="noStrike" noProof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Reference standard</a:t>
                      </a:r>
                      <a:endParaRPr lang="en-US" sz="700" b="1" i="1" u="none" strike="noStrike" noProof="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1" u="none" strike="noStrike" noProof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Limit of </a:t>
                      </a:r>
                      <a:r>
                        <a:rPr lang="en-US" sz="700" b="1" i="1" u="none" strike="noStrike" noProof="0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detection</a:t>
                      </a:r>
                      <a:r>
                        <a:rPr lang="en-US" sz="700" b="1" i="1" u="none" strike="noStrike" baseline="0" noProof="0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r>
                        <a:rPr lang="en-US" sz="700" b="1" i="1" u="none" strike="noStrike" noProof="0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(</a:t>
                      </a:r>
                      <a:r>
                        <a:rPr lang="en-US" sz="700" b="1" i="1" u="none" strike="noStrike" noProof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based on standard curve)</a:t>
                      </a:r>
                      <a:endParaRPr lang="en-US" sz="700" b="1" i="1" u="none" strike="noStrike" noProof="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1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Reference</a:t>
                      </a:r>
                      <a:endParaRPr lang="en-US" sz="700" b="1" i="1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24050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athogens</a:t>
                      </a:r>
                      <a:endParaRPr lang="en-US" sz="700" b="1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1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1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1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1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1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14507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i="1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G. lamblia </a:t>
                      </a:r>
                      <a:r>
                        <a:rPr lang="en-US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8S rRNA</a:t>
                      </a:r>
                      <a:endParaRPr lang="en-US" sz="700" b="0" i="1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Giardia-80F</a:t>
                      </a:r>
                      <a:endParaRPr lang="en-US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GACGGCTCAGGACAACGGTT</a:t>
                      </a:r>
                      <a:endParaRPr lang="en-US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700" u="none" strike="noStrike" noProof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62 bp</a:t>
                      </a:r>
                      <a:endParaRPr lang="is-IS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i="1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Giardia lamblia </a:t>
                      </a:r>
                      <a:r>
                        <a:rPr lang="en-US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H3 cysts</a:t>
                      </a:r>
                      <a:endParaRPr lang="en-US" sz="700" b="0" i="1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noProof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00 cysts </a:t>
                      </a:r>
                      <a:endParaRPr lang="en-US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Bartelt, 2013</a:t>
                      </a:r>
                      <a:endParaRPr lang="nl-NL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14507">
                <a:tc>
                  <a:txBody>
                    <a:bodyPr/>
                    <a:lstStyle/>
                    <a:p>
                      <a:pPr algn="l" fontAlgn="b"/>
                      <a:r>
                        <a:rPr lang="sk-SK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</a:t>
                      </a:r>
                      <a:endParaRPr lang="sk-SK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Giardia-127R</a:t>
                      </a:r>
                      <a:endParaRPr lang="en-US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TTGCCAGCGGTGTCCG</a:t>
                      </a:r>
                      <a:endParaRPr lang="en-US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</a:t>
                      </a:r>
                      <a:endParaRPr lang="sk-SK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</a:t>
                      </a:r>
                      <a:endParaRPr lang="sk-SK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</a:t>
                      </a:r>
                      <a:endParaRPr lang="sk-SK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</a:t>
                      </a:r>
                      <a:endParaRPr lang="sk-SK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</a:tr>
              <a:tr h="114507">
                <a:tc>
                  <a:txBody>
                    <a:bodyPr/>
                    <a:lstStyle/>
                    <a:p>
                      <a:pPr algn="l" fontAlgn="b"/>
                      <a:r>
                        <a:rPr lang="sk-SK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</a:t>
                      </a:r>
                      <a:endParaRPr lang="sk-SK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Giardia-105T</a:t>
                      </a:r>
                      <a:endParaRPr lang="en-US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FAM-CCCGCGGCGGTCCCTGCTAG-BHQ</a:t>
                      </a:r>
                      <a:endParaRPr lang="en-US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</a:t>
                      </a:r>
                      <a:endParaRPr lang="sk-SK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</a:t>
                      </a:r>
                      <a:endParaRPr lang="sk-SK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</a:t>
                      </a:r>
                      <a:endParaRPr lang="sk-SK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</a:t>
                      </a:r>
                      <a:endParaRPr lang="sk-SK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</a:tr>
              <a:tr h="114507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EAEC </a:t>
                      </a:r>
                      <a:r>
                        <a:rPr lang="en-US" sz="700" i="1" u="none" strike="noStrike" noProof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ap</a:t>
                      </a:r>
                      <a:endParaRPr lang="en-US" sz="700" b="0" i="1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ap-F</a:t>
                      </a:r>
                      <a:endParaRPr lang="en-US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TTGGGTATCAGCCTGAATG</a:t>
                      </a:r>
                      <a:endParaRPr lang="en-US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700" u="none" strike="noStrike" noProof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348 bp</a:t>
                      </a:r>
                      <a:endParaRPr lang="is-IS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noProof="0" dirty="0" err="1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enteroaggregative</a:t>
                      </a:r>
                      <a:r>
                        <a:rPr lang="en-US" sz="700" u="none" strike="noStrike" noProof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r>
                        <a:rPr lang="en-US" sz="700" i="1" u="none" strike="noStrike" noProof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Escherichia </a:t>
                      </a:r>
                      <a:r>
                        <a:rPr lang="en-US" sz="700" i="1" u="none" strike="noStrike" noProof="0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oli </a:t>
                      </a:r>
                      <a:r>
                        <a:rPr lang="en-US" sz="700" u="none" strike="noStrike" noProof="0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42</a:t>
                      </a:r>
                      <a:endParaRPr lang="en-US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noProof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0 CFU</a:t>
                      </a:r>
                      <a:endParaRPr lang="fr-FR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Bolick, 2013</a:t>
                      </a:r>
                      <a:endParaRPr lang="en-US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14507">
                <a:tc>
                  <a:txBody>
                    <a:bodyPr/>
                    <a:lstStyle/>
                    <a:p>
                      <a:pPr algn="l" fontAlgn="b"/>
                      <a:r>
                        <a:rPr lang="sk-SK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</a:t>
                      </a:r>
                      <a:endParaRPr lang="sk-SK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ap-R</a:t>
                      </a:r>
                      <a:endParaRPr lang="en-US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ACCCATTCGGTTAGAGCAC</a:t>
                      </a:r>
                      <a:endParaRPr lang="en-US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</a:t>
                      </a:r>
                      <a:endParaRPr lang="sk-SK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</a:t>
                      </a:r>
                      <a:endParaRPr lang="sk-SK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</a:t>
                      </a:r>
                      <a:endParaRPr lang="sk-SK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</a:t>
                      </a:r>
                      <a:endParaRPr lang="sk-SK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</a:tr>
              <a:tr h="114507"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24050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Bacteria Group</a:t>
                      </a:r>
                      <a:endParaRPr lang="en-US" sz="700" b="1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14507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Total bacteria (Universal 16S rRNA)</a:t>
                      </a:r>
                      <a:endParaRPr lang="en-US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Uni-F</a:t>
                      </a:r>
                      <a:endParaRPr lang="en-US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GTGSTGCAYGGYTGTCGTCA</a:t>
                      </a:r>
                      <a:endParaRPr lang="en-US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noProof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47</a:t>
                      </a:r>
                      <a:r>
                        <a:rPr lang="is-IS" sz="700" u="none" strike="noStrike" noProof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bp</a:t>
                      </a:r>
                      <a:endParaRPr lang="en-US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i="1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Enterococcus faecalis </a:t>
                      </a:r>
                      <a:r>
                        <a:rPr lang="en-US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OG1RFD genomic DNA</a:t>
                      </a:r>
                      <a:endParaRPr lang="en-US" sz="700" b="0" i="1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u="none" strike="noStrike" noProof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40 </a:t>
                      </a:r>
                      <a:r>
                        <a:rPr lang="it-IT" sz="700" u="none" strike="noStrike" noProof="0" dirty="0" err="1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opies</a:t>
                      </a:r>
                      <a:r>
                        <a:rPr lang="it-IT" sz="700" u="none" strike="noStrike" noProof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per 0.0001 </a:t>
                      </a:r>
                      <a:r>
                        <a:rPr lang="it-IT" sz="700" u="none" strike="noStrike" noProof="0" dirty="0" err="1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ng</a:t>
                      </a:r>
                      <a:r>
                        <a:rPr lang="it-IT" sz="700" u="none" strike="noStrike" noProof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DNA</a:t>
                      </a:r>
                      <a:endParaRPr lang="it-IT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noProof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ackey,</a:t>
                      </a:r>
                      <a:r>
                        <a:rPr lang="en-US" sz="700" u="none" strike="noStrike" baseline="0" noProof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2013</a:t>
                      </a:r>
                      <a:endParaRPr lang="en-US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14507">
                <a:tc>
                  <a:txBody>
                    <a:bodyPr/>
                    <a:lstStyle/>
                    <a:p>
                      <a:pPr algn="l" fontAlgn="b"/>
                      <a:r>
                        <a:rPr lang="sk-SK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</a:t>
                      </a:r>
                      <a:endParaRPr lang="sk-SK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Uni-R</a:t>
                      </a:r>
                      <a:endParaRPr lang="en-US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CGTCRTCCMCACCTTCCTC</a:t>
                      </a:r>
                      <a:endParaRPr lang="en-US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</a:t>
                      </a:r>
                      <a:endParaRPr lang="sk-SK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</a:t>
                      </a:r>
                      <a:endParaRPr lang="sk-SK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</a:t>
                      </a:r>
                      <a:endParaRPr lang="sk-SK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</a:t>
                      </a:r>
                      <a:endParaRPr lang="sk-SK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</a:tr>
              <a:tr h="114507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noProof="0" dirty="0" err="1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Bacteroidetes</a:t>
                      </a:r>
                      <a:r>
                        <a:rPr lang="en-US" sz="700" u="none" strike="noStrike" noProof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phyla</a:t>
                      </a:r>
                      <a:endParaRPr lang="en-US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Bact-934</a:t>
                      </a:r>
                      <a:endParaRPr lang="mr-IN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GGARCATGTGGTTTAATTCGATGAT</a:t>
                      </a:r>
                      <a:endParaRPr lang="en-US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tr-TR" sz="700" u="none" strike="noStrike" noProof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26</a:t>
                      </a:r>
                      <a:r>
                        <a:rPr lang="is-IS" sz="700" u="none" strike="noStrike" noProof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bp</a:t>
                      </a:r>
                      <a:endParaRPr lang="tr-TR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i="1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Bacteroidetes fragilis</a:t>
                      </a:r>
                      <a:endParaRPr lang="en-US" sz="700" b="0" i="1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noProof="0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00 </a:t>
                      </a:r>
                      <a:r>
                        <a:rPr lang="fr-FR" sz="700" u="none" strike="noStrike" noProof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FU</a:t>
                      </a:r>
                      <a:endParaRPr lang="fr-FR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Moore, 2016</a:t>
                      </a:r>
                      <a:endParaRPr lang="en-US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14507">
                <a:tc>
                  <a:txBody>
                    <a:bodyPr/>
                    <a:lstStyle/>
                    <a:p>
                      <a:pPr algn="l" fontAlgn="b"/>
                      <a:r>
                        <a:rPr lang="sk-SK" sz="700" u="none" strike="noStrike" noProof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</a:t>
                      </a:r>
                      <a:endParaRPr lang="sk-SK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Bact-106</a:t>
                      </a:r>
                      <a:endParaRPr lang="mr-IN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GCTGACGACAACCATGCAG</a:t>
                      </a:r>
                      <a:endParaRPr lang="en-US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</a:t>
                      </a:r>
                      <a:endParaRPr lang="sk-SK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</a:t>
                      </a:r>
                      <a:endParaRPr lang="sk-SK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700" u="none" strike="noStrike" noProof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</a:t>
                      </a:r>
                      <a:endParaRPr lang="sk-SK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</a:t>
                      </a:r>
                      <a:endParaRPr lang="sk-SK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</a:tr>
              <a:tr h="114507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noProof="0" dirty="0" err="1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Firmicutes</a:t>
                      </a:r>
                      <a:r>
                        <a:rPr lang="en-US" sz="700" u="none" strike="noStrike" noProof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phyla</a:t>
                      </a:r>
                      <a:endParaRPr lang="en-US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Firm-350</a:t>
                      </a:r>
                      <a:endParaRPr lang="mr-IN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GGCAGCAGTRGGGAATCTTC</a:t>
                      </a:r>
                      <a:endParaRPr lang="en-US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700" u="none" strike="noStrike" noProof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484 bp</a:t>
                      </a:r>
                      <a:endParaRPr lang="is-IS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i="1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Lactobacillus reuteri</a:t>
                      </a:r>
                      <a:endParaRPr lang="en-US" sz="700" b="0" i="1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noProof="0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00 </a:t>
                      </a:r>
                      <a:r>
                        <a:rPr lang="fr-FR" sz="700" u="none" strike="noStrike" noProof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FU</a:t>
                      </a:r>
                      <a:endParaRPr lang="fr-FR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Moore, 2016</a:t>
                      </a:r>
                      <a:endParaRPr lang="en-US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14507">
                <a:tc>
                  <a:txBody>
                    <a:bodyPr/>
                    <a:lstStyle/>
                    <a:p>
                      <a:pPr algn="l" fontAlgn="b"/>
                      <a:r>
                        <a:rPr lang="sk-SK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</a:t>
                      </a:r>
                      <a:endParaRPr lang="sk-SK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Firm-814</a:t>
                      </a:r>
                      <a:endParaRPr lang="mr-IN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CACYTAGYACTCATCGTTT</a:t>
                      </a:r>
                      <a:endParaRPr lang="en-US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</a:t>
                      </a:r>
                      <a:endParaRPr lang="sk-SK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</a:t>
                      </a:r>
                      <a:endParaRPr lang="sk-SK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700" u="none" strike="noStrike" noProof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</a:t>
                      </a:r>
                      <a:endParaRPr lang="sk-SK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</a:t>
                      </a:r>
                      <a:endParaRPr lang="sk-SK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</a:tr>
              <a:tr h="114507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i="1" u="none" strike="noStrike" noProof="0" dirty="0" err="1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Enterobacteriaceae</a:t>
                      </a:r>
                      <a:r>
                        <a:rPr lang="en-US" sz="700" u="none" strike="noStrike" noProof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family</a:t>
                      </a:r>
                      <a:endParaRPr lang="en-US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uk-UA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Uni515</a:t>
                      </a:r>
                      <a:endParaRPr lang="uk-UA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GTGCCAGCMGCCGCGGTAA</a:t>
                      </a:r>
                      <a:endParaRPr lang="en-US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noProof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355</a:t>
                      </a:r>
                      <a:r>
                        <a:rPr lang="is-IS" sz="700" u="none" strike="noStrike" noProof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bp</a:t>
                      </a:r>
                      <a:endParaRPr lang="en-US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i="1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Escherichia </a:t>
                      </a:r>
                      <a:r>
                        <a:rPr lang="en-US" sz="700" i="1" u="none" strike="noStrike" noProof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oli</a:t>
                      </a:r>
                      <a:endParaRPr lang="en-US" sz="700" b="0" i="1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noProof="0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00 </a:t>
                      </a:r>
                      <a:r>
                        <a:rPr lang="fr-FR" sz="700" u="none" strike="noStrike" noProof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FU</a:t>
                      </a:r>
                      <a:endParaRPr lang="fr-FR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Moore, 2016</a:t>
                      </a:r>
                      <a:endParaRPr lang="en-US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14507">
                <a:tc>
                  <a:txBody>
                    <a:bodyPr/>
                    <a:lstStyle/>
                    <a:p>
                      <a:pPr algn="l" fontAlgn="b"/>
                      <a:r>
                        <a:rPr lang="sk-SK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</a:t>
                      </a:r>
                      <a:endParaRPr lang="sk-SK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Ent826</a:t>
                      </a:r>
                      <a:endParaRPr lang="de-DE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GCCTCAAGGGCACAACCTCCAAG</a:t>
                      </a:r>
                      <a:endParaRPr lang="en-US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</a:t>
                      </a:r>
                      <a:endParaRPr lang="sk-SK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</a:t>
                      </a:r>
                      <a:endParaRPr lang="sk-SK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700" u="none" strike="noStrike" noProof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</a:t>
                      </a:r>
                      <a:endParaRPr lang="sk-SK" sz="700" b="0" i="0" u="none" strike="noStrike" noProof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700" u="none" strike="noStrike" noProof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</a:t>
                      </a:r>
                      <a:endParaRPr lang="sk-SK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9542" marR="9542" marT="95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</a:tr>
            </a:tbl>
          </a:graphicData>
        </a:graphic>
      </p:graphicFrame>
      <p:sp>
        <p:nvSpPr>
          <p:cNvPr id="8" name="Rectangle 7"/>
          <p:cNvSpPr/>
          <p:nvPr/>
        </p:nvSpPr>
        <p:spPr>
          <a:xfrm>
            <a:off x="308811" y="2745394"/>
            <a:ext cx="9765821" cy="21236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Supplemental Table:  List of gene targets and primer sequences used in this study.</a:t>
            </a:r>
          </a:p>
          <a:p>
            <a:endParaRPr lang="en-US" sz="1200" dirty="0">
              <a:effectLst/>
              <a:latin typeface="Arial" charset="0"/>
              <a:ea typeface="Arial" charset="0"/>
              <a:cs typeface="Arial" charset="0"/>
            </a:endParaRPr>
          </a:p>
          <a:p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qPCR references:</a:t>
            </a:r>
            <a:endParaRPr lang="en-US" sz="12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1200" dirty="0" smtClean="0">
                <a:effectLst/>
                <a:latin typeface="Arial" charset="0"/>
                <a:ea typeface="Arial" charset="0"/>
                <a:cs typeface="Arial" charset="0"/>
              </a:rPr>
              <a:t>   Bartelt LA, Roche J, </a:t>
            </a:r>
            <a:r>
              <a:rPr lang="en-US" sz="1200" dirty="0" err="1" smtClean="0">
                <a:effectLst/>
                <a:latin typeface="Arial" charset="0"/>
                <a:ea typeface="Arial" charset="0"/>
                <a:cs typeface="Arial" charset="0"/>
              </a:rPr>
              <a:t>Kolling</a:t>
            </a:r>
            <a:r>
              <a:rPr lang="en-US" sz="1200" dirty="0" smtClean="0">
                <a:effectLst/>
                <a:latin typeface="Arial" charset="0"/>
                <a:ea typeface="Arial" charset="0"/>
                <a:cs typeface="Arial" charset="0"/>
              </a:rPr>
              <a:t> G, </a:t>
            </a:r>
            <a:r>
              <a:rPr lang="en-US" sz="1200" dirty="0" err="1" smtClean="0">
                <a:effectLst/>
                <a:latin typeface="Arial" charset="0"/>
                <a:ea typeface="Arial" charset="0"/>
                <a:cs typeface="Arial" charset="0"/>
              </a:rPr>
              <a:t>Bolick</a:t>
            </a:r>
            <a:r>
              <a:rPr lang="en-US" sz="1200" dirty="0" smtClean="0">
                <a:effectLst/>
                <a:latin typeface="Arial" charset="0"/>
                <a:ea typeface="Arial" charset="0"/>
                <a:cs typeface="Arial" charset="0"/>
              </a:rPr>
              <a:t> D, Noronha F, Naylor C, et al. Persistent G. lamblia impairs growth in a murine malnutrition model. J </a:t>
            </a:r>
            <a:r>
              <a:rPr lang="en-US" sz="1200" dirty="0" err="1" smtClean="0">
                <a:effectLst/>
                <a:latin typeface="Arial" charset="0"/>
                <a:ea typeface="Arial" charset="0"/>
                <a:cs typeface="Arial" charset="0"/>
              </a:rPr>
              <a:t>Clin</a:t>
            </a:r>
            <a:r>
              <a:rPr lang="en-US" sz="1200" dirty="0" smtClean="0">
                <a:effectLst/>
                <a:latin typeface="Arial" charset="0"/>
                <a:ea typeface="Arial" charset="0"/>
                <a:cs typeface="Arial" charset="0"/>
              </a:rPr>
              <a:t> Invest. 2013;123(6):2672-84.</a:t>
            </a:r>
          </a:p>
          <a:p>
            <a:r>
              <a:rPr lang="en-US" sz="1200" dirty="0" smtClean="0">
                <a:effectLst/>
                <a:latin typeface="Arial" charset="0"/>
                <a:ea typeface="Arial" charset="0"/>
                <a:cs typeface="Arial" charset="0"/>
              </a:rPr>
              <a:t>   </a:t>
            </a:r>
            <a:r>
              <a:rPr lang="en-US" sz="1200" dirty="0" err="1" smtClean="0">
                <a:effectLst/>
                <a:latin typeface="Arial" charset="0"/>
                <a:ea typeface="Arial" charset="0"/>
                <a:cs typeface="Arial" charset="0"/>
              </a:rPr>
              <a:t>Bolick</a:t>
            </a:r>
            <a:r>
              <a:rPr lang="en-US" sz="1200" dirty="0" smtClean="0">
                <a:effectLst/>
                <a:latin typeface="Arial" charset="0"/>
                <a:ea typeface="Arial" charset="0"/>
                <a:cs typeface="Arial" charset="0"/>
              </a:rPr>
              <a:t> DT, </a:t>
            </a:r>
            <a:r>
              <a:rPr lang="en-US" sz="1200" dirty="0" err="1" smtClean="0">
                <a:effectLst/>
                <a:latin typeface="Arial" charset="0"/>
                <a:ea typeface="Arial" charset="0"/>
                <a:cs typeface="Arial" charset="0"/>
              </a:rPr>
              <a:t>Kolling</a:t>
            </a:r>
            <a:r>
              <a:rPr lang="en-US" sz="1200" dirty="0" smtClean="0">
                <a:effectLst/>
                <a:latin typeface="Arial" charset="0"/>
                <a:ea typeface="Arial" charset="0"/>
                <a:cs typeface="Arial" charset="0"/>
              </a:rPr>
              <a:t> GL, Moore JH, 2nd, de Oliveira LA, Tung K, Philipson C, et al. Zinc deficiency alters host response and pathogen virulence in a mouse model of </a:t>
            </a:r>
            <a:r>
              <a:rPr lang="en-US" sz="1200" dirty="0" err="1" smtClean="0">
                <a:effectLst/>
                <a:latin typeface="Arial" charset="0"/>
                <a:ea typeface="Arial" charset="0"/>
                <a:cs typeface="Arial" charset="0"/>
              </a:rPr>
              <a:t>enteroaggregative</a:t>
            </a:r>
            <a:r>
              <a:rPr lang="en-US" sz="1200" dirty="0" smtClean="0">
                <a:effectLst/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200" dirty="0" err="1" smtClean="0">
                <a:effectLst/>
                <a:latin typeface="Arial" charset="0"/>
                <a:ea typeface="Arial" charset="0"/>
                <a:cs typeface="Arial" charset="0"/>
              </a:rPr>
              <a:t>escherichia</a:t>
            </a:r>
            <a:r>
              <a:rPr lang="en-US" sz="1200" dirty="0" smtClean="0">
                <a:effectLst/>
                <a:latin typeface="Arial" charset="0"/>
                <a:ea typeface="Arial" charset="0"/>
                <a:cs typeface="Arial" charset="0"/>
              </a:rPr>
              <a:t> coli-induced diarrhea. Gut Microbes. 2014;5(5):618-27. </a:t>
            </a:r>
            <a:endParaRPr lang="en-US" sz="12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1200" dirty="0" smtClean="0">
                <a:effectLst/>
                <a:latin typeface="Arial" charset="0"/>
                <a:ea typeface="Arial" charset="0"/>
                <a:cs typeface="Arial" charset="0"/>
              </a:rPr>
              <a:t>   </a:t>
            </a:r>
            <a:r>
              <a:rPr lang="en-US" sz="1200" dirty="0" err="1" smtClean="0">
                <a:effectLst/>
                <a:latin typeface="Arial" charset="0"/>
                <a:ea typeface="Arial" charset="0"/>
                <a:cs typeface="Arial" charset="0"/>
              </a:rPr>
              <a:t>Packey</a:t>
            </a:r>
            <a:r>
              <a:rPr lang="en-US" sz="1200" dirty="0" smtClean="0">
                <a:effectLst/>
                <a:latin typeface="Arial" charset="0"/>
                <a:ea typeface="Arial" charset="0"/>
                <a:cs typeface="Arial" charset="0"/>
              </a:rPr>
              <a:t> CD, Shanahan MT, </a:t>
            </a:r>
            <a:r>
              <a:rPr lang="en-US" sz="1200" dirty="0" err="1" smtClean="0">
                <a:effectLst/>
                <a:latin typeface="Arial" charset="0"/>
                <a:ea typeface="Arial" charset="0"/>
                <a:cs typeface="Arial" charset="0"/>
              </a:rPr>
              <a:t>Manick</a:t>
            </a:r>
            <a:r>
              <a:rPr lang="en-US" sz="1200" dirty="0" smtClean="0">
                <a:effectLst/>
                <a:latin typeface="Arial" charset="0"/>
                <a:ea typeface="Arial" charset="0"/>
                <a:cs typeface="Arial" charset="0"/>
              </a:rPr>
              <a:t> S, Bower MA, </a:t>
            </a:r>
            <a:r>
              <a:rPr lang="en-US" sz="1200" dirty="0" err="1" smtClean="0">
                <a:effectLst/>
                <a:latin typeface="Arial" charset="0"/>
                <a:ea typeface="Arial" charset="0"/>
                <a:cs typeface="Arial" charset="0"/>
              </a:rPr>
              <a:t>Ellerman</a:t>
            </a:r>
            <a:r>
              <a:rPr lang="en-US" sz="1200" dirty="0" smtClean="0">
                <a:effectLst/>
                <a:latin typeface="Arial" charset="0"/>
                <a:ea typeface="Arial" charset="0"/>
                <a:cs typeface="Arial" charset="0"/>
              </a:rPr>
              <a:t> M, </a:t>
            </a:r>
            <a:r>
              <a:rPr lang="en-US" sz="1200" dirty="0" err="1" smtClean="0">
                <a:effectLst/>
                <a:latin typeface="Arial" charset="0"/>
                <a:ea typeface="Arial" charset="0"/>
                <a:cs typeface="Arial" charset="0"/>
              </a:rPr>
              <a:t>Tonkonogy</a:t>
            </a:r>
            <a:r>
              <a:rPr lang="en-US" sz="1200" dirty="0" smtClean="0">
                <a:effectLst/>
                <a:latin typeface="Arial" charset="0"/>
                <a:ea typeface="Arial" charset="0"/>
                <a:cs typeface="Arial" charset="0"/>
              </a:rPr>
              <a:t> SL, Carroll IM, Sartor RB, Molecular detection of bacterial contamination in </a:t>
            </a:r>
            <a:r>
              <a:rPr lang="en-US" sz="1200" dirty="0" err="1" smtClean="0">
                <a:effectLst/>
                <a:latin typeface="Arial" charset="0"/>
                <a:ea typeface="Arial" charset="0"/>
                <a:cs typeface="Arial" charset="0"/>
              </a:rPr>
              <a:t>gnotobiotic</a:t>
            </a:r>
            <a:r>
              <a:rPr lang="en-US" sz="1200" dirty="0" smtClean="0">
                <a:effectLst/>
                <a:latin typeface="Arial" charset="0"/>
                <a:ea typeface="Arial" charset="0"/>
                <a:cs typeface="Arial" charset="0"/>
              </a:rPr>
              <a:t> rodent units. Gut Microbes. 2013; 4(5):351070. </a:t>
            </a:r>
            <a:endParaRPr lang="en-US" sz="1200" dirty="0" smtClean="0">
              <a:latin typeface="Arial" charset="0"/>
              <a:ea typeface="Arial" charset="0"/>
              <a:cs typeface="Arial" charset="0"/>
            </a:endParaRPr>
          </a:p>
          <a:p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   Moore J., </a:t>
            </a:r>
            <a:r>
              <a:rPr lang="en-US" sz="1200" dirty="0" err="1" smtClean="0">
                <a:latin typeface="Arial" charset="0"/>
                <a:ea typeface="Arial" charset="0"/>
                <a:cs typeface="Arial" charset="0"/>
              </a:rPr>
              <a:t>Pinheiro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 C., </a:t>
            </a:r>
            <a:r>
              <a:rPr lang="en-US" sz="1200" dirty="0" err="1" smtClean="0">
                <a:latin typeface="Arial" charset="0"/>
                <a:ea typeface="Arial" charset="0"/>
                <a:cs typeface="Arial" charset="0"/>
              </a:rPr>
              <a:t>Zaenker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 E., </a:t>
            </a:r>
            <a:r>
              <a:rPr lang="en-US" sz="1200" dirty="0" err="1" smtClean="0">
                <a:latin typeface="Arial" charset="0"/>
                <a:ea typeface="Arial" charset="0"/>
                <a:cs typeface="Arial" charset="0"/>
              </a:rPr>
              <a:t>Bolick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 D., </a:t>
            </a:r>
            <a:r>
              <a:rPr lang="en-US" sz="1200" dirty="0" err="1" smtClean="0">
                <a:latin typeface="Arial" charset="0"/>
                <a:ea typeface="Arial" charset="0"/>
                <a:cs typeface="Arial" charset="0"/>
              </a:rPr>
              <a:t>Kolling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 G., et al. Defined nutrient diets alter susceptibility to Clostridium difficile associated disease in a murine model. </a:t>
            </a:r>
            <a:r>
              <a:rPr lang="en-US" sz="1200" dirty="0" err="1" smtClean="0">
                <a:latin typeface="Arial" charset="0"/>
                <a:ea typeface="Arial" charset="0"/>
                <a:cs typeface="Arial" charset="0"/>
              </a:rPr>
              <a:t>PLoS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 One. 2015; 10(7): e0131829</a:t>
            </a:r>
            <a:endParaRPr lang="en-US" sz="12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340311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</TotalTime>
  <Words>383</Words>
  <Application>Microsoft Macintosh PowerPoint</Application>
  <PresentationFormat>Custom</PresentationFormat>
  <Paragraphs>10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ther Bartelt</dc:creator>
  <cp:lastModifiedBy>Luther Bartelt</cp:lastModifiedBy>
  <cp:revision>7</cp:revision>
  <cp:lastPrinted>2017-05-11T15:46:41Z</cp:lastPrinted>
  <dcterms:created xsi:type="dcterms:W3CDTF">2017-05-11T15:45:02Z</dcterms:created>
  <dcterms:modified xsi:type="dcterms:W3CDTF">2017-05-14T01:18:27Z</dcterms:modified>
</cp:coreProperties>
</file>